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5" r:id="rId3"/>
    <p:sldId id="268" r:id="rId4"/>
    <p:sldId id="267" r:id="rId5"/>
    <p:sldId id="259" r:id="rId6"/>
    <p:sldId id="260" r:id="rId7"/>
    <p:sldId id="261" r:id="rId8"/>
    <p:sldId id="262" r:id="rId9"/>
    <p:sldId id="263" r:id="rId10"/>
    <p:sldId id="264" r:id="rId11"/>
    <p:sldId id="25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6" autoAdjust="0"/>
    <p:restoredTop sz="94660"/>
  </p:normalViewPr>
  <p:slideViewPr>
    <p:cSldViewPr snapToGrid="0">
      <p:cViewPr varScale="1">
        <p:scale>
          <a:sx n="82" d="100"/>
          <a:sy n="82" d="100"/>
        </p:scale>
        <p:origin x="71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 smtClean="0"/>
              <a:t>Kattintson ide az alcím mintájának szerkesztéséhez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830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4703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4357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0925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074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815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9844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4074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221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8446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2881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8335A7-A5BA-4026-A2A9-DFAAEB6EFA42}" type="datetimeFigureOut">
              <a:rPr lang="en-GB" smtClean="0"/>
              <a:t>13/10/2021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B244B5-9578-45EE-8766-CEA42A92D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2575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606829" y="1039675"/>
            <a:ext cx="1821332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rgbClr val="3333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endParaRPr kumimoji="0" lang="en-GB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lang="hu-HU" alt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1</a:t>
            </a:r>
            <a:endParaRPr kumimoji="0" lang="en-GB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25" name="Kép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829" y="1637607"/>
            <a:ext cx="2466975" cy="1752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2677120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69" name="Kép 2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475" y="457200"/>
            <a:ext cx="5724525" cy="5657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61150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6" name="Rectangle 2"/>
          <p:cNvSpPr>
            <a:spLocks noChangeArrowheads="1"/>
          </p:cNvSpPr>
          <p:nvPr/>
        </p:nvSpPr>
        <p:spPr bwMode="auto">
          <a:xfrm>
            <a:off x="141316" y="117855"/>
            <a:ext cx="3175462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kumimoji="0" lang="hu-HU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</a:t>
            </a:r>
            <a:r>
              <a:rPr lang="hu-HU" altLang="en-US" sz="800" dirty="0">
                <a:latin typeface="Arial" panose="020B0604020202020204" pitchFamily="34" charset="0"/>
              </a:rPr>
              <a:t> </a:t>
            </a:r>
            <a:r>
              <a:rPr lang="hu-HU" altLang="en-US" sz="1200" dirty="0">
                <a:latin typeface="Arial" panose="020B0604020202020204" pitchFamily="34" charset="0"/>
              </a:rPr>
              <a:t>C</a:t>
            </a:r>
            <a:endParaRPr kumimoji="0" lang="en-GB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755844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Csoportba foglalás 18"/>
          <p:cNvGrpSpPr/>
          <p:nvPr/>
        </p:nvGrpSpPr>
        <p:grpSpPr>
          <a:xfrm>
            <a:off x="685789" y="1319633"/>
            <a:ext cx="3091520" cy="4314162"/>
            <a:chOff x="3564456" y="1251899"/>
            <a:chExt cx="3091520" cy="4314162"/>
          </a:xfrm>
        </p:grpSpPr>
        <p:grpSp>
          <p:nvGrpSpPr>
            <p:cNvPr id="17" name="Csoportba foglalás 16"/>
            <p:cNvGrpSpPr/>
            <p:nvPr/>
          </p:nvGrpSpPr>
          <p:grpSpPr>
            <a:xfrm>
              <a:off x="3564456" y="2332244"/>
              <a:ext cx="2999950" cy="3233817"/>
              <a:chOff x="1609725" y="857250"/>
              <a:chExt cx="3543300" cy="3819525"/>
            </a:xfrm>
          </p:grpSpPr>
          <p:pic>
            <p:nvPicPr>
              <p:cNvPr id="2" name="Kép 1"/>
              <p:cNvPicPr>
                <a:picLocks noChangeAspect="1"/>
              </p:cNvPicPr>
              <p:nvPr/>
            </p:nvPicPr>
            <p:blipFill rotWithShape="1">
              <a:blip r:embed="rId2"/>
              <a:srcRect l="2465" r="33138" b="336"/>
              <a:stretch/>
            </p:blipFill>
            <p:spPr>
              <a:xfrm>
                <a:off x="2995624" y="2613637"/>
                <a:ext cx="1366825" cy="390382"/>
              </a:xfrm>
              <a:prstGeom prst="rect">
                <a:avLst/>
              </a:prstGeom>
            </p:spPr>
          </p:pic>
          <p:pic>
            <p:nvPicPr>
              <p:cNvPr id="3" name="Kép 2"/>
              <p:cNvPicPr>
                <a:picLocks noChangeAspect="1"/>
              </p:cNvPicPr>
              <p:nvPr/>
            </p:nvPicPr>
            <p:blipFill rotWithShape="1">
              <a:blip r:embed="rId3"/>
              <a:srcRect l="23026" t="81240" r="59508" b="8642"/>
              <a:stretch/>
            </p:blipFill>
            <p:spPr>
              <a:xfrm>
                <a:off x="2999551" y="3118629"/>
                <a:ext cx="1362899" cy="367521"/>
              </a:xfrm>
              <a:prstGeom prst="rect">
                <a:avLst/>
              </a:prstGeom>
            </p:spPr>
          </p:pic>
          <p:pic>
            <p:nvPicPr>
              <p:cNvPr id="4" name="Kép 3"/>
              <p:cNvPicPr>
                <a:picLocks noChangeAspect="1"/>
              </p:cNvPicPr>
              <p:nvPr/>
            </p:nvPicPr>
            <p:blipFill rotWithShape="1">
              <a:blip r:embed="rId4"/>
              <a:srcRect l="45255" t="58801" r="35857" b="19604"/>
              <a:stretch/>
            </p:blipFill>
            <p:spPr>
              <a:xfrm>
                <a:off x="2993615" y="3609329"/>
                <a:ext cx="1368833" cy="385475"/>
              </a:xfrm>
              <a:prstGeom prst="rect">
                <a:avLst/>
              </a:prstGeom>
            </p:spPr>
          </p:pic>
          <p:sp>
            <p:nvSpPr>
              <p:cNvPr id="5" name="Szövegdoboz 4"/>
              <p:cNvSpPr txBox="1"/>
              <p:nvPr/>
            </p:nvSpPr>
            <p:spPr>
              <a:xfrm>
                <a:off x="2751289" y="1176074"/>
                <a:ext cx="1867530" cy="10326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1524" dirty="0">
                    <a:latin typeface="Arial" panose="020B0604020202020204" pitchFamily="34" charset="0"/>
                    <a:cs typeface="Arial" panose="020B0604020202020204" pitchFamily="34" charset="0"/>
                  </a:rPr>
                  <a:t>HUMAN</a:t>
                </a:r>
              </a:p>
              <a:p>
                <a:pPr algn="ctr"/>
                <a:endParaRPr lang="hu-HU" sz="847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hu-HU" sz="847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</a:t>
                </a:r>
                <a:r>
                  <a:rPr lang="hu-HU" sz="847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-ABDOMINAL </a:t>
                </a:r>
              </a:p>
              <a:p>
                <a:r>
                  <a:rPr lang="hu-HU" sz="847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</a:t>
                </a:r>
              </a:p>
              <a:p>
                <a:r>
                  <a:rPr lang="hu-HU" sz="1016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endParaRPr lang="en-GB" sz="1016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Szövegdoboz 5"/>
              <p:cNvSpPr txBox="1"/>
              <p:nvPr/>
            </p:nvSpPr>
            <p:spPr>
              <a:xfrm>
                <a:off x="3117267" y="2160490"/>
                <a:ext cx="1488311" cy="3860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152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 -     +           </a:t>
                </a:r>
                <a:endParaRPr lang="en-GB" sz="1524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Szövegdoboz 6"/>
              <p:cNvSpPr txBox="1"/>
              <p:nvPr/>
            </p:nvSpPr>
            <p:spPr>
              <a:xfrm>
                <a:off x="3131373" y="1907604"/>
                <a:ext cx="1474205" cy="3860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152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+     -            </a:t>
                </a:r>
                <a:endParaRPr lang="en-GB" sz="1524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" name="Csoportba foglalás 7"/>
              <p:cNvGrpSpPr/>
              <p:nvPr/>
            </p:nvGrpSpPr>
            <p:grpSpPr>
              <a:xfrm>
                <a:off x="2061056" y="1905132"/>
                <a:ext cx="1509624" cy="2106429"/>
                <a:chOff x="4242098" y="1199096"/>
                <a:chExt cx="1509624" cy="2106429"/>
              </a:xfrm>
            </p:grpSpPr>
            <p:sp>
              <p:nvSpPr>
                <p:cNvPr id="9" name="Szövegdoboz 8"/>
                <p:cNvSpPr txBox="1"/>
                <p:nvPr/>
              </p:nvSpPr>
              <p:spPr>
                <a:xfrm>
                  <a:off x="4242098" y="1199096"/>
                  <a:ext cx="1181820" cy="386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524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ypoxia</a:t>
                  </a:r>
                  <a:endParaRPr lang="en-GB" sz="1524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Szövegdoboz 9"/>
                <p:cNvSpPr txBox="1"/>
                <p:nvPr/>
              </p:nvSpPr>
              <p:spPr>
                <a:xfrm>
                  <a:off x="4354243" y="1517322"/>
                  <a:ext cx="1397479" cy="386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524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AMP</a:t>
                  </a:r>
                  <a:r>
                    <a:rPr lang="hu-HU" sz="1524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endParaRPr lang="en-GB" sz="1524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Szövegdoboz 10"/>
                <p:cNvSpPr txBox="1"/>
                <p:nvPr/>
              </p:nvSpPr>
              <p:spPr>
                <a:xfrm>
                  <a:off x="4355878" y="1903624"/>
                  <a:ext cx="888695" cy="386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524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IF1A</a:t>
                  </a:r>
                  <a:endParaRPr lang="en-GB" sz="1524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Szövegdoboz 11"/>
                <p:cNvSpPr txBox="1"/>
                <p:nvPr/>
              </p:nvSpPr>
              <p:spPr>
                <a:xfrm>
                  <a:off x="4354243" y="2398726"/>
                  <a:ext cx="871446" cy="386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524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CP1</a:t>
                  </a:r>
                  <a:endParaRPr lang="en-GB" sz="1524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Szövegdoboz 12"/>
                <p:cNvSpPr txBox="1"/>
                <p:nvPr/>
              </p:nvSpPr>
              <p:spPr>
                <a:xfrm>
                  <a:off x="4354243" y="2919436"/>
                  <a:ext cx="905774" cy="386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524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B</a:t>
                  </a:r>
                  <a:endParaRPr lang="en-GB" sz="1524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" name="Téglalap 13"/>
              <p:cNvSpPr/>
              <p:nvPr/>
            </p:nvSpPr>
            <p:spPr>
              <a:xfrm>
                <a:off x="1609725" y="857250"/>
                <a:ext cx="3543300" cy="3609975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524"/>
              </a:p>
            </p:txBody>
          </p:sp>
          <p:sp>
            <p:nvSpPr>
              <p:cNvPr id="15" name="Téglalap 14"/>
              <p:cNvSpPr/>
              <p:nvPr/>
            </p:nvSpPr>
            <p:spPr>
              <a:xfrm>
                <a:off x="1771649" y="933450"/>
                <a:ext cx="3381376" cy="374332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524"/>
              </a:p>
            </p:txBody>
          </p:sp>
        </p:grpSp>
        <p:sp>
          <p:nvSpPr>
            <p:cNvPr id="16" name="Téglalap 15"/>
            <p:cNvSpPr/>
            <p:nvPr/>
          </p:nvSpPr>
          <p:spPr>
            <a:xfrm>
              <a:off x="3609981" y="1251899"/>
              <a:ext cx="3045995" cy="103053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GB" sz="1524" b="1" dirty="0">
                  <a:latin typeface="Arial" panose="020B0604020202020204" pitchFamily="34" charset="0"/>
                  <a:cs typeface="Arial" panose="020B0604020202020204" pitchFamily="34" charset="0"/>
                </a:rPr>
                <a:t>The </a:t>
              </a:r>
              <a:r>
                <a:rPr lang="hu-HU" sz="1524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ffect</a:t>
              </a:r>
              <a:r>
                <a:rPr lang="en-GB" sz="1524" b="1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hu-HU" sz="1524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hermogenic</a:t>
              </a:r>
              <a:r>
                <a:rPr lang="hu-HU" sz="1524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hu-HU" sz="1524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duction</a:t>
              </a:r>
              <a:r>
                <a:rPr lang="hu-HU" sz="1524" b="1" dirty="0">
                  <a:latin typeface="Arial" panose="020B0604020202020204" pitchFamily="34" charset="0"/>
                  <a:cs typeface="Arial" panose="020B0604020202020204" pitchFamily="34" charset="0"/>
                </a:rPr>
                <a:t> and </a:t>
              </a:r>
              <a:r>
                <a:rPr lang="hu-HU" sz="1524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ypoxic</a:t>
              </a:r>
              <a:r>
                <a:rPr lang="hu-HU" sz="1524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hu-HU" sz="1524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ndition</a:t>
              </a:r>
              <a:r>
                <a:rPr lang="hu-HU" sz="1524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hu-HU" sz="1524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en-GB" sz="1524" b="1" dirty="0">
                  <a:latin typeface="Arial" panose="020B0604020202020204" pitchFamily="34" charset="0"/>
                  <a:cs typeface="Arial" panose="020B0604020202020204" pitchFamily="34" charset="0"/>
                </a:rPr>
                <a:t> the </a:t>
              </a:r>
              <a:r>
                <a:rPr lang="hu-HU" sz="1524" b="1" dirty="0">
                  <a:latin typeface="Arial" panose="020B0604020202020204" pitchFamily="34" charset="0"/>
                  <a:cs typeface="Arial" panose="020B0604020202020204" pitchFamily="34" charset="0"/>
                </a:rPr>
                <a:t>protein </a:t>
              </a:r>
              <a:r>
                <a:rPr lang="hu-HU" sz="1524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evel</a:t>
              </a:r>
              <a:r>
                <a:rPr lang="en-GB" sz="1524" b="1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hu-HU" sz="1524" b="1" dirty="0">
                  <a:latin typeface="Arial" panose="020B0604020202020204" pitchFamily="34" charset="0"/>
                  <a:cs typeface="Arial" panose="020B0604020202020204" pitchFamily="34" charset="0"/>
                </a:rPr>
                <a:t>HIF1A and UCP1</a:t>
              </a:r>
              <a:endParaRPr lang="en-GB" sz="1524" dirty="0"/>
            </a:p>
          </p:txBody>
        </p:sp>
      </p:grpSp>
      <p:sp>
        <p:nvSpPr>
          <p:cNvPr id="20" name="Szövegdoboz 19"/>
          <p:cNvSpPr txBox="1"/>
          <p:nvPr/>
        </p:nvSpPr>
        <p:spPr>
          <a:xfrm>
            <a:off x="685789" y="303123"/>
            <a:ext cx="2476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err="1" smtClean="0"/>
              <a:t>Supplementary</a:t>
            </a:r>
            <a:r>
              <a:rPr lang="hu-HU" dirty="0" smtClean="0"/>
              <a:t> </a:t>
            </a:r>
            <a:r>
              <a:rPr lang="hu-HU" dirty="0" err="1" smtClean="0"/>
              <a:t>Figure</a:t>
            </a:r>
            <a:r>
              <a:rPr lang="hu-HU" dirty="0" smtClean="0"/>
              <a:t> 6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161316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églalap 1"/>
          <p:cNvSpPr/>
          <p:nvPr/>
        </p:nvSpPr>
        <p:spPr>
          <a:xfrm>
            <a:off x="343251" y="176938"/>
            <a:ext cx="28929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hu-HU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GB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hu-HU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</a:t>
            </a:r>
            <a:r>
              <a:rPr lang="en-GB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en-GB" dirty="0"/>
          </a:p>
        </p:txBody>
      </p:sp>
      <p:pic>
        <p:nvPicPr>
          <p:cNvPr id="5" name="Kép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240" y="767697"/>
            <a:ext cx="9647434" cy="589216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488366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971" y="667822"/>
            <a:ext cx="11865656" cy="59462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églalap 2"/>
          <p:cNvSpPr/>
          <p:nvPr/>
        </p:nvSpPr>
        <p:spPr>
          <a:xfrm>
            <a:off x="343251" y="176938"/>
            <a:ext cx="29056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hu-HU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GB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hu-HU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B</a:t>
            </a:r>
            <a:r>
              <a:rPr lang="en-GB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659983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églalap 1"/>
          <p:cNvSpPr/>
          <p:nvPr/>
        </p:nvSpPr>
        <p:spPr>
          <a:xfrm>
            <a:off x="343251" y="176938"/>
            <a:ext cx="29184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hu-HU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GB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hu-HU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C</a:t>
            </a:r>
            <a:r>
              <a:rPr lang="en-GB" b="1" dirty="0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en-GB" dirty="0"/>
          </a:p>
        </p:txBody>
      </p:sp>
      <p:pic>
        <p:nvPicPr>
          <p:cNvPr id="3" name="Kép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493" y="857782"/>
            <a:ext cx="8061010" cy="4930652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728310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zövegdoboz 1"/>
          <p:cNvSpPr txBox="1">
            <a:spLocks noChangeArrowheads="1"/>
          </p:cNvSpPr>
          <p:nvPr/>
        </p:nvSpPr>
        <p:spPr bwMode="auto">
          <a:xfrm>
            <a:off x="241070" y="983846"/>
            <a:ext cx="2857500" cy="25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hu-HU" altLang="en-US" sz="1100" b="1" i="0" u="none" strike="noStrike" cap="none" normalizeH="0" baseline="0" smtClean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u-HU" altLang="en-US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ker-genes from BATLAS database</a:t>
            </a:r>
            <a:endParaRPr kumimoji="0" lang="hu-HU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049" name="Kép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075" y="1768302"/>
            <a:ext cx="5761037" cy="2019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Szövegdoboz 16"/>
          <p:cNvSpPr txBox="1">
            <a:spLocks noChangeArrowheads="1"/>
          </p:cNvSpPr>
          <p:nvPr/>
        </p:nvSpPr>
        <p:spPr bwMode="auto">
          <a:xfrm>
            <a:off x="3298220" y="1149437"/>
            <a:ext cx="2857500" cy="25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u-HU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ker-</a:t>
            </a:r>
            <a:r>
              <a:rPr kumimoji="0" lang="hu-HU" altLang="en-US" sz="11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nes</a:t>
            </a:r>
            <a:r>
              <a:rPr kumimoji="0" lang="hu-HU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hu-HU" altLang="en-US" sz="11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rom</a:t>
            </a:r>
            <a:r>
              <a:rPr kumimoji="0" lang="hu-HU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hu-HU" altLang="en-US" sz="11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FAT</a:t>
            </a:r>
            <a:r>
              <a:rPr kumimoji="0" lang="hu-HU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hu-HU" altLang="en-US" sz="11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base</a:t>
            </a:r>
            <a:endParaRPr kumimoji="0" lang="hu-HU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241070" y="166839"/>
            <a:ext cx="3862660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kumimoji="0" lang="hu-HU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endParaRPr kumimoji="0" lang="en-GB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                                                                                B</a:t>
            </a:r>
            <a:endParaRPr kumimoji="0" lang="en-GB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Rectangle 5"/>
          <p:cNvSpPr>
            <a:spLocks noChangeArrowheads="1"/>
          </p:cNvSpPr>
          <p:nvPr/>
        </p:nvSpPr>
        <p:spPr bwMode="auto">
          <a:xfrm>
            <a:off x="241070" y="764771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9329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57447" y="141403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                                                                               D</a:t>
            </a:r>
            <a:endParaRPr kumimoji="0" lang="en-GB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3073" name="image3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953" y="457200"/>
            <a:ext cx="5657850" cy="2876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333375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8409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5"/>
          <p:cNvSpPr>
            <a:spLocks noChangeArrowheads="1"/>
          </p:cNvSpPr>
          <p:nvPr/>
        </p:nvSpPr>
        <p:spPr bwMode="auto">
          <a:xfrm>
            <a:off x="538843" y="75287"/>
            <a:ext cx="1821332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kumimoji="0" lang="hu-HU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4</a:t>
            </a:r>
            <a:endParaRPr kumimoji="0" lang="en-GB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4100" name="Kép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843" y="505599"/>
            <a:ext cx="5753100" cy="2828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6"/>
          <p:cNvSpPr>
            <a:spLocks noChangeArrowheads="1"/>
          </p:cNvSpPr>
          <p:nvPr/>
        </p:nvSpPr>
        <p:spPr bwMode="auto">
          <a:xfrm>
            <a:off x="0" y="328612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45047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141316" y="117855"/>
            <a:ext cx="3175462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kumimoji="0" lang="hu-HU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</a:t>
            </a:r>
            <a:r>
              <a:rPr lang="hu-HU" altLang="en-US" sz="800" dirty="0">
                <a:latin typeface="Arial" panose="020B0604020202020204" pitchFamily="34" charset="0"/>
              </a:rPr>
              <a:t> 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endParaRPr kumimoji="0" lang="en-GB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5121" name="Kép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"/>
            <a:ext cx="5753100" cy="6038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64960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43574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Kép 6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"/>
            <a:ext cx="5772150" cy="6410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686752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141316" y="117855"/>
            <a:ext cx="3175462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kumimoji="0" lang="hu-HU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</a:t>
            </a:r>
            <a:r>
              <a:rPr lang="hu-HU" altLang="en-US" sz="800" dirty="0">
                <a:latin typeface="Arial" panose="020B0604020202020204" pitchFamily="34" charset="0"/>
              </a:rPr>
              <a:t> </a:t>
            </a:r>
            <a:r>
              <a:rPr lang="hu-HU" altLang="en-US" sz="1200" dirty="0">
                <a:latin typeface="Arial" panose="020B0604020202020204" pitchFamily="34" charset="0"/>
              </a:rPr>
              <a:t>B</a:t>
            </a:r>
            <a:endParaRPr kumimoji="0" lang="en-GB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95635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83</TotalTime>
  <Words>85</Words>
  <Application>Microsoft Office PowerPoint</Application>
  <PresentationFormat>Szélesvásznú</PresentationFormat>
  <Paragraphs>29</Paragraphs>
  <Slides>1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-téma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Tóth Bea</dc:creator>
  <cp:lastModifiedBy>Tóth Bea</cp:lastModifiedBy>
  <cp:revision>31</cp:revision>
  <dcterms:created xsi:type="dcterms:W3CDTF">2021-02-05T13:37:43Z</dcterms:created>
  <dcterms:modified xsi:type="dcterms:W3CDTF">2021-10-13T15:11:23Z</dcterms:modified>
</cp:coreProperties>
</file>